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0753D85-2C3F-47A8-B237-F3551EE86835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390B2C-7DCC-4A2E-9DB8-6F79EACF64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597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8515AB-7C51-9E4B-8CC2-F2E55B85F87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84103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8515AB-7C51-9E4B-8CC2-F2E55B85F87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750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072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54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017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70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786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341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881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672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33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403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004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D3EE9-EDC1-4ED1-BD29-13FF49C74E49}" type="datetimeFigureOut">
              <a:rPr lang="en-US" smtClean="0"/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6C5B48-C34F-4AD8-9BEA-EAE0D43DF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319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="" xmlns:a16="http://schemas.microsoft.com/office/drawing/2014/main" id="{8C963B7A-254A-094A-B78B-CF62EE324E2A}"/>
              </a:ext>
            </a:extLst>
          </p:cNvPr>
          <p:cNvGrpSpPr/>
          <p:nvPr/>
        </p:nvGrpSpPr>
        <p:grpSpPr>
          <a:xfrm>
            <a:off x="7340406" y="893324"/>
            <a:ext cx="4247598" cy="4239739"/>
            <a:chOff x="925732" y="872476"/>
            <a:chExt cx="4297462" cy="4185132"/>
          </a:xfrm>
        </p:grpSpPr>
        <p:pic>
          <p:nvPicPr>
            <p:cNvPr id="3" name="Picture 2">
              <a:extLst>
                <a:ext uri="{FF2B5EF4-FFF2-40B4-BE49-F238E27FC236}">
                  <a16:creationId xmlns="" xmlns:a16="http://schemas.microsoft.com/office/drawing/2014/main" id="{89174ED1-6EEB-1045-91EB-917E2461609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1758943" y="1676400"/>
              <a:ext cx="2736857" cy="13815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" name="Rectangle 3">
              <a:extLst>
                <a:ext uri="{FF2B5EF4-FFF2-40B4-BE49-F238E27FC236}">
                  <a16:creationId xmlns="" xmlns:a16="http://schemas.microsoft.com/office/drawing/2014/main" id="{67F948EC-87AD-7C43-A101-8B2521F60466}"/>
                </a:ext>
              </a:extLst>
            </p:cNvPr>
            <p:cNvSpPr/>
            <p:nvPr/>
          </p:nvSpPr>
          <p:spPr>
            <a:xfrm rot="17772080">
              <a:off x="2052519" y="4530541"/>
              <a:ext cx="80021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/>
                <a:t>KP8/pTE18</a:t>
              </a:r>
            </a:p>
          </p:txBody>
        </p:sp>
        <p:pic>
          <p:nvPicPr>
            <p:cNvPr id="5" name="Picture 2">
              <a:extLst>
                <a:ext uri="{FF2B5EF4-FFF2-40B4-BE49-F238E27FC236}">
                  <a16:creationId xmlns="" xmlns:a16="http://schemas.microsoft.com/office/drawing/2014/main" id="{AA128C2C-BDE2-F048-80E4-2A9942988B6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509"/>
            <a:stretch/>
          </p:blipFill>
          <p:spPr bwMode="auto">
            <a:xfrm>
              <a:off x="1715185" y="3080445"/>
              <a:ext cx="2824372" cy="12570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887EFFE4-6647-B441-A1DF-E070C4DF04B6}"/>
                </a:ext>
              </a:extLst>
            </p:cNvPr>
            <p:cNvSpPr txBox="1"/>
            <p:nvPr/>
          </p:nvSpPr>
          <p:spPr>
            <a:xfrm>
              <a:off x="971273" y="1248975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7ED4E461-27A4-6544-A3AA-C850B0CBBD6C}"/>
                </a:ext>
              </a:extLst>
            </p:cNvPr>
            <p:cNvSpPr txBox="1"/>
            <p:nvPr/>
          </p:nvSpPr>
          <p:spPr>
            <a:xfrm>
              <a:off x="1004124" y="3239943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="" xmlns:a16="http://schemas.microsoft.com/office/drawing/2014/main" id="{F10D47ED-8499-604C-A570-A4FF5CA8B652}"/>
                </a:ext>
              </a:extLst>
            </p:cNvPr>
            <p:cNvSpPr/>
            <p:nvPr/>
          </p:nvSpPr>
          <p:spPr>
            <a:xfrm rot="1643972">
              <a:off x="4305955" y="3574431"/>
              <a:ext cx="91723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/>
                <a:t>KP8 /pBR322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="" xmlns:a16="http://schemas.microsoft.com/office/drawing/2014/main" id="{2B39FE65-9141-9B4C-B63A-56E95B5516AB}"/>
                </a:ext>
              </a:extLst>
            </p:cNvPr>
            <p:cNvSpPr/>
            <p:nvPr/>
          </p:nvSpPr>
          <p:spPr>
            <a:xfrm rot="3252919">
              <a:off x="3557101" y="4349872"/>
              <a:ext cx="793807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/>
                <a:t>MC4100KP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="" xmlns:a16="http://schemas.microsoft.com/office/drawing/2014/main" id="{35F51940-9237-984B-A1D3-AA6314FFBFCD}"/>
                </a:ext>
              </a:extLst>
            </p:cNvPr>
            <p:cNvSpPr/>
            <p:nvPr/>
          </p:nvSpPr>
          <p:spPr>
            <a:xfrm rot="5810343">
              <a:off x="3160308" y="1204138"/>
              <a:ext cx="91723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/>
                <a:t>KP8 /pBR322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="" xmlns:a16="http://schemas.microsoft.com/office/drawing/2014/main" id="{D8906C29-0AB9-D84F-B9C7-0361F05857AA}"/>
                </a:ext>
              </a:extLst>
            </p:cNvPr>
            <p:cNvSpPr/>
            <p:nvPr/>
          </p:nvSpPr>
          <p:spPr>
            <a:xfrm rot="3428744">
              <a:off x="1972275" y="1390579"/>
              <a:ext cx="80021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/>
                <a:t>KP8/pTE18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="" xmlns:a16="http://schemas.microsoft.com/office/drawing/2014/main" id="{EF91A5C6-DEDD-2749-B870-13810AE2DD36}"/>
                </a:ext>
              </a:extLst>
            </p:cNvPr>
            <p:cNvSpPr/>
            <p:nvPr/>
          </p:nvSpPr>
          <p:spPr>
            <a:xfrm rot="19788096">
              <a:off x="4295620" y="2076660"/>
              <a:ext cx="800219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b="1" dirty="0"/>
                <a:t>KP8/pTE18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="" xmlns:a16="http://schemas.microsoft.com/office/drawing/2014/main" id="{96746BE3-DF0F-FC4E-BE2E-10493C3C4F63}"/>
                </a:ext>
              </a:extLst>
            </p:cNvPr>
            <p:cNvSpPr txBox="1"/>
            <p:nvPr/>
          </p:nvSpPr>
          <p:spPr>
            <a:xfrm rot="1009448">
              <a:off x="925732" y="2114673"/>
              <a:ext cx="1015585" cy="410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>
                  <a:cs typeface="Aharoni" pitchFamily="2" charset="-79"/>
                </a:rPr>
                <a:t>KP37 (MC4100</a:t>
              </a:r>
            </a:p>
            <a:p>
              <a:pPr algn="ctr"/>
              <a:r>
                <a:rPr lang="en-US" sz="1050" b="1" dirty="0">
                  <a:cs typeface="Aharoni" pitchFamily="2" charset="-79"/>
                </a:rPr>
                <a:t> </a:t>
              </a:r>
              <a:r>
                <a:rPr lang="en-US" sz="1050" b="1" i="1" dirty="0" err="1">
                  <a:cs typeface="Aharoni" pitchFamily="2" charset="-79"/>
                </a:rPr>
                <a:t>relA</a:t>
              </a:r>
              <a:r>
                <a:rPr lang="en-US" sz="1050" b="1" baseline="30000" dirty="0">
                  <a:cs typeface="Aharoni" pitchFamily="2" charset="-79"/>
                </a:rPr>
                <a:t>+ </a:t>
              </a:r>
              <a:r>
                <a:rPr lang="en-US" sz="1050" b="1" i="1" dirty="0" err="1">
                  <a:cs typeface="Aharoni" pitchFamily="2" charset="-79"/>
                </a:rPr>
                <a:t>spoT</a:t>
              </a:r>
              <a:r>
                <a:rPr lang="en-US" sz="1050" b="1" baseline="30000" dirty="0">
                  <a:cs typeface="Aharoni" pitchFamily="2" charset="-79"/>
                </a:rPr>
                <a:t>+</a:t>
              </a:r>
              <a:r>
                <a:rPr lang="en-US" sz="1050" b="1" dirty="0">
                  <a:cs typeface="Aharoni" pitchFamily="2" charset="-79"/>
                </a:rPr>
                <a:t>)</a:t>
              </a:r>
              <a:endParaRPr lang="en-US" sz="1050" b="1" baseline="30000" dirty="0">
                <a:cs typeface="Aharoni" pitchFamily="2" charset="-79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49384EB2-0E60-574A-A51C-983D688A2189}"/>
                </a:ext>
              </a:extLst>
            </p:cNvPr>
            <p:cNvSpPr txBox="1"/>
            <p:nvPr/>
          </p:nvSpPr>
          <p:spPr>
            <a:xfrm rot="20459324">
              <a:off x="1002222" y="3548181"/>
              <a:ext cx="1015585" cy="410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>
                  <a:cs typeface="Aharoni" pitchFamily="2" charset="-79"/>
                </a:rPr>
                <a:t>KP37 (MC4100</a:t>
              </a:r>
            </a:p>
            <a:p>
              <a:pPr algn="ctr"/>
              <a:r>
                <a:rPr lang="en-US" sz="1050" b="1" dirty="0">
                  <a:cs typeface="Aharoni" pitchFamily="2" charset="-79"/>
                </a:rPr>
                <a:t> </a:t>
              </a:r>
              <a:r>
                <a:rPr lang="en-US" sz="1050" b="1" i="1" dirty="0" err="1">
                  <a:cs typeface="Aharoni" pitchFamily="2" charset="-79"/>
                </a:rPr>
                <a:t>relA</a:t>
              </a:r>
              <a:r>
                <a:rPr lang="en-US" sz="1050" b="1" baseline="30000" dirty="0">
                  <a:cs typeface="Aharoni" pitchFamily="2" charset="-79"/>
                </a:rPr>
                <a:t>+ </a:t>
              </a:r>
              <a:r>
                <a:rPr lang="en-US" sz="1050" b="1" i="1" dirty="0" err="1">
                  <a:cs typeface="Aharoni" pitchFamily="2" charset="-79"/>
                </a:rPr>
                <a:t>spoT</a:t>
              </a:r>
              <a:r>
                <a:rPr lang="en-US" sz="1050" b="1" baseline="30000" dirty="0">
                  <a:cs typeface="Aharoni" pitchFamily="2" charset="-79"/>
                </a:rPr>
                <a:t>+</a:t>
              </a:r>
              <a:r>
                <a:rPr lang="en-US" sz="1050" b="1" dirty="0">
                  <a:cs typeface="Aharoni" pitchFamily="2" charset="-79"/>
                </a:rPr>
                <a:t>)</a:t>
              </a:r>
              <a:endParaRPr lang="en-US" sz="1050" b="1" baseline="30000" dirty="0">
                <a:cs typeface="Aharoni" pitchFamily="2" charset="-79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29BC1FD5-6B48-7141-BF06-A363A7B0C880}"/>
              </a:ext>
            </a:extLst>
          </p:cNvPr>
          <p:cNvSpPr txBox="1"/>
          <p:nvPr/>
        </p:nvSpPr>
        <p:spPr>
          <a:xfrm>
            <a:off x="306606" y="523992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S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7C9E8FAB-9334-9A44-B83D-5175CC9C096B}"/>
              </a:ext>
            </a:extLst>
          </p:cNvPr>
          <p:cNvSpPr txBox="1"/>
          <p:nvPr/>
        </p:nvSpPr>
        <p:spPr>
          <a:xfrm>
            <a:off x="6600240" y="523992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2</a:t>
            </a:r>
          </a:p>
        </p:txBody>
      </p:sp>
      <p:graphicFrame>
        <p:nvGraphicFramePr>
          <p:cNvPr id="19" name="Object 18">
            <a:extLst>
              <a:ext uri="{FF2B5EF4-FFF2-40B4-BE49-F238E27FC236}">
                <a16:creationId xmlns="" xmlns:a16="http://schemas.microsoft.com/office/drawing/2014/main" id="{7317A71B-384C-E94D-8D8F-F327322CBA8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3323" y="1097310"/>
          <a:ext cx="6018213" cy="4043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6" r:id="rId5" imgW="6018948" imgH="4043449" progId="Prism6.Document">
                  <p:embed/>
                </p:oleObj>
              </mc:Choice>
              <mc:Fallback>
                <p:oleObj name="Prism 6" r:id="rId5" imgW="6018948" imgH="4043449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3323" y="1097310"/>
                        <a:ext cx="6018213" cy="40433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893515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4E39973C-57B0-DA46-8114-77ABDDC3F4F0}"/>
              </a:ext>
            </a:extLst>
          </p:cNvPr>
          <p:cNvSpPr txBox="1"/>
          <p:nvPr/>
        </p:nvSpPr>
        <p:spPr>
          <a:xfrm>
            <a:off x="412812" y="227038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3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="" xmlns:a16="http://schemas.microsoft.com/office/drawing/2014/main" id="{9BD3467E-B052-BD42-B635-04A899BF87E1}"/>
              </a:ext>
            </a:extLst>
          </p:cNvPr>
          <p:cNvGrpSpPr/>
          <p:nvPr/>
        </p:nvGrpSpPr>
        <p:grpSpPr>
          <a:xfrm>
            <a:off x="1517485" y="173473"/>
            <a:ext cx="10080957" cy="4386495"/>
            <a:chOff x="236223" y="568600"/>
            <a:chExt cx="8036197" cy="3320234"/>
          </a:xfrm>
        </p:grpSpPr>
        <p:pic>
          <p:nvPicPr>
            <p:cNvPr id="29" name="Picture 28">
              <a:extLst>
                <a:ext uri="{FF2B5EF4-FFF2-40B4-BE49-F238E27FC236}">
                  <a16:creationId xmlns="" xmlns:a16="http://schemas.microsoft.com/office/drawing/2014/main" id="{7069F2B7-C05E-EF4D-8B17-C43E82D552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90" t="18177" r="2688" b="13960"/>
            <a:stretch/>
          </p:blipFill>
          <p:spPr>
            <a:xfrm>
              <a:off x="1461700" y="1170160"/>
              <a:ext cx="2377439" cy="2377440"/>
            </a:xfrm>
            <a:prstGeom prst="ellipse">
              <a:avLst/>
            </a:prstGeom>
            <a:ln>
              <a:noFill/>
            </a:ln>
            <a:effectLst>
              <a:softEdge rad="112500"/>
            </a:effectLst>
          </p:spPr>
        </p:pic>
        <p:sp>
          <p:nvSpPr>
            <p:cNvPr id="30" name="TextBox 29">
              <a:extLst>
                <a:ext uri="{FF2B5EF4-FFF2-40B4-BE49-F238E27FC236}">
                  <a16:creationId xmlns="" xmlns:a16="http://schemas.microsoft.com/office/drawing/2014/main" id="{7874AD5B-DEBB-3643-8393-85D841DBB6DB}"/>
                </a:ext>
              </a:extLst>
            </p:cNvPr>
            <p:cNvSpPr txBox="1"/>
            <p:nvPr/>
          </p:nvSpPr>
          <p:spPr>
            <a:xfrm>
              <a:off x="893614" y="1059893"/>
              <a:ext cx="1277957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/>
                <a:t>KP52</a:t>
              </a:r>
            </a:p>
            <a:p>
              <a:pPr algn="ctr"/>
              <a:r>
                <a:rPr lang="en-US" sz="1050" b="1" dirty="0"/>
                <a:t>(MG1655 </a:t>
              </a:r>
              <a:r>
                <a:rPr lang="en-US" sz="1050" b="1" i="1" dirty="0"/>
                <a:t>relA1</a:t>
              </a:r>
              <a:r>
                <a:rPr lang="en-US" sz="1050" b="1" dirty="0"/>
                <a:t>)</a:t>
              </a:r>
              <a:endParaRPr lang="en-US" sz="1050" b="1" i="1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="" xmlns:a16="http://schemas.microsoft.com/office/drawing/2014/main" id="{3B7C7659-E7A2-2E4F-A714-CC38D3161DA1}"/>
                </a:ext>
              </a:extLst>
            </p:cNvPr>
            <p:cNvSpPr txBox="1"/>
            <p:nvPr/>
          </p:nvSpPr>
          <p:spPr>
            <a:xfrm>
              <a:off x="2872766" y="860129"/>
              <a:ext cx="141096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/>
                <a:t>KP53</a:t>
              </a:r>
            </a:p>
            <a:p>
              <a:pPr algn="ctr"/>
              <a:r>
                <a:rPr lang="en-US" sz="1050" b="1" dirty="0"/>
                <a:t>(MG1655 </a:t>
              </a:r>
              <a:r>
                <a:rPr lang="en-US" sz="1050" b="1" i="1" dirty="0"/>
                <a:t>relA1spoT1</a:t>
              </a:r>
              <a:r>
                <a:rPr lang="en-US" sz="1050" b="1" dirty="0"/>
                <a:t>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="" xmlns:a16="http://schemas.microsoft.com/office/drawing/2014/main" id="{721BA5AD-1A2D-8D48-96C9-74602F03BE98}"/>
                </a:ext>
              </a:extLst>
            </p:cNvPr>
            <p:cNvSpPr txBox="1"/>
            <p:nvPr/>
          </p:nvSpPr>
          <p:spPr>
            <a:xfrm>
              <a:off x="3586977" y="1606813"/>
              <a:ext cx="9733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/>
                <a:t>KP31</a:t>
              </a:r>
            </a:p>
            <a:p>
              <a:pPr algn="ctr"/>
              <a:r>
                <a:rPr lang="en-US" sz="900" b="1" dirty="0"/>
                <a:t>(MG1655 </a:t>
              </a:r>
              <a:r>
                <a:rPr lang="en-US" sz="900" b="1" i="1" dirty="0"/>
                <a:t>spoT1</a:t>
              </a:r>
              <a:r>
                <a:rPr lang="en-US" sz="900" b="1" dirty="0"/>
                <a:t>)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="" xmlns:a16="http://schemas.microsoft.com/office/drawing/2014/main" id="{E4E11C90-A349-CC46-B6FC-B127D7220396}"/>
                </a:ext>
              </a:extLst>
            </p:cNvPr>
            <p:cNvSpPr txBox="1"/>
            <p:nvPr/>
          </p:nvSpPr>
          <p:spPr>
            <a:xfrm>
              <a:off x="3158348" y="3104386"/>
              <a:ext cx="121539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/>
                <a:t>KP55</a:t>
              </a:r>
            </a:p>
            <a:p>
              <a:pPr algn="ctr"/>
              <a:r>
                <a:rPr lang="en-US" sz="1050" b="1" dirty="0"/>
                <a:t>(MG1655 </a:t>
              </a:r>
              <a:r>
                <a:rPr lang="en-US" sz="1050" b="1" i="1" dirty="0"/>
                <a:t>relA101</a:t>
              </a:r>
              <a:r>
                <a:rPr lang="en-US" sz="1050" b="1" dirty="0"/>
                <a:t>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="" xmlns:a16="http://schemas.microsoft.com/office/drawing/2014/main" id="{876FF601-7863-8941-921D-AF1655FB99FE}"/>
                </a:ext>
              </a:extLst>
            </p:cNvPr>
            <p:cNvSpPr txBox="1"/>
            <p:nvPr/>
          </p:nvSpPr>
          <p:spPr>
            <a:xfrm>
              <a:off x="236223" y="2854682"/>
              <a:ext cx="1550425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/>
                <a:t>KP54</a:t>
              </a:r>
            </a:p>
            <a:p>
              <a:pPr algn="ctr"/>
              <a:r>
                <a:rPr lang="en-US" sz="1050" b="1" dirty="0"/>
                <a:t>(MG1655 </a:t>
              </a:r>
              <a:r>
                <a:rPr lang="en-US" sz="1050" b="1" i="1" dirty="0"/>
                <a:t>relA101spoT</a:t>
              </a:r>
              <a:r>
                <a:rPr lang="en-US" sz="1050" b="1" dirty="0"/>
                <a:t>1)</a:t>
              </a:r>
            </a:p>
          </p:txBody>
        </p:sp>
        <p:pic>
          <p:nvPicPr>
            <p:cNvPr id="36" name="Picture 35">
              <a:extLst>
                <a:ext uri="{FF2B5EF4-FFF2-40B4-BE49-F238E27FC236}">
                  <a16:creationId xmlns="" xmlns:a16="http://schemas.microsoft.com/office/drawing/2014/main" id="{82E575D5-1F84-BA4B-9F36-B0430836AE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96" t="18370" r="6484" b="13735"/>
            <a:stretch/>
          </p:blipFill>
          <p:spPr>
            <a:xfrm>
              <a:off x="5246018" y="1205466"/>
              <a:ext cx="2318372" cy="2377440"/>
            </a:xfrm>
            <a:prstGeom prst="ellipse">
              <a:avLst/>
            </a:prstGeom>
            <a:ln>
              <a:solidFill>
                <a:srgbClr val="FF0000"/>
              </a:solidFill>
            </a:ln>
            <a:effectLst>
              <a:softEdge rad="112500"/>
            </a:effectLst>
          </p:spPr>
        </p:pic>
        <p:sp>
          <p:nvSpPr>
            <p:cNvPr id="37" name="TextBox 36">
              <a:extLst>
                <a:ext uri="{FF2B5EF4-FFF2-40B4-BE49-F238E27FC236}">
                  <a16:creationId xmlns="" xmlns:a16="http://schemas.microsoft.com/office/drawing/2014/main" id="{61BDA870-BC71-084A-A7A6-9D3A2450E4EC}"/>
                </a:ext>
              </a:extLst>
            </p:cNvPr>
            <p:cNvSpPr txBox="1"/>
            <p:nvPr/>
          </p:nvSpPr>
          <p:spPr>
            <a:xfrm>
              <a:off x="5012566" y="3372304"/>
              <a:ext cx="101021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/>
                <a:t>MC4100/ pTE6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="" xmlns:a16="http://schemas.microsoft.com/office/drawing/2014/main" id="{D8519DF6-E3F0-E244-A158-A88D42FEE953}"/>
                </a:ext>
              </a:extLst>
            </p:cNvPr>
            <p:cNvSpPr txBox="1"/>
            <p:nvPr/>
          </p:nvSpPr>
          <p:spPr>
            <a:xfrm>
              <a:off x="6077546" y="982500"/>
              <a:ext cx="104868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/>
                <a:t>MC4100/pTE22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="" xmlns:a16="http://schemas.microsoft.com/office/drawing/2014/main" id="{9F60A178-875A-6342-8D4E-AD16852B0461}"/>
                </a:ext>
              </a:extLst>
            </p:cNvPr>
            <p:cNvSpPr txBox="1"/>
            <p:nvPr/>
          </p:nvSpPr>
          <p:spPr>
            <a:xfrm>
              <a:off x="7424111" y="2523709"/>
              <a:ext cx="84830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/>
                <a:t>MC4100/ </a:t>
              </a:r>
            </a:p>
            <a:p>
              <a:pPr algn="ctr"/>
              <a:r>
                <a:rPr lang="en-US" sz="1050" b="1" dirty="0"/>
                <a:t>pBAD18Kan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="" xmlns:a16="http://schemas.microsoft.com/office/drawing/2014/main" id="{BD6787EE-DB75-EB46-A300-31295A1CAF9D}"/>
                </a:ext>
              </a:extLst>
            </p:cNvPr>
            <p:cNvSpPr txBox="1"/>
            <p:nvPr/>
          </p:nvSpPr>
          <p:spPr>
            <a:xfrm rot="2902297">
              <a:off x="6826038" y="3431497"/>
              <a:ext cx="66075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50" b="1" dirty="0"/>
                <a:t>MG165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="" xmlns:a16="http://schemas.microsoft.com/office/drawing/2014/main" id="{1174FB7C-1AA8-454A-BB8C-ACA0C275FF9F}"/>
                </a:ext>
              </a:extLst>
            </p:cNvPr>
            <p:cNvSpPr txBox="1"/>
            <p:nvPr/>
          </p:nvSpPr>
          <p:spPr>
            <a:xfrm>
              <a:off x="1119401" y="613168"/>
              <a:ext cx="4284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.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="" xmlns:a16="http://schemas.microsoft.com/office/drawing/2014/main" id="{68163C32-01AF-B446-98C3-A7CE0174BD79}"/>
                </a:ext>
              </a:extLst>
            </p:cNvPr>
            <p:cNvSpPr txBox="1"/>
            <p:nvPr/>
          </p:nvSpPr>
          <p:spPr>
            <a:xfrm>
              <a:off x="5097221" y="568600"/>
              <a:ext cx="4284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.</a:t>
              </a:r>
            </a:p>
          </p:txBody>
        </p:sp>
        <p:cxnSp>
          <p:nvCxnSpPr>
            <p:cNvPr id="48" name="Straight Connector 47">
              <a:extLst>
                <a:ext uri="{FF2B5EF4-FFF2-40B4-BE49-F238E27FC236}">
                  <a16:creationId xmlns="" xmlns:a16="http://schemas.microsoft.com/office/drawing/2014/main" id="{981BDE3A-0276-6F40-9697-391C8792B21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47904" y="1141602"/>
              <a:ext cx="931076" cy="55102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" name="Straight Connector 48">
              <a:extLst>
                <a:ext uri="{FF2B5EF4-FFF2-40B4-BE49-F238E27FC236}">
                  <a16:creationId xmlns="" xmlns:a16="http://schemas.microsoft.com/office/drawing/2014/main" id="{CC3CB3B2-F54E-D94C-AD73-C339C9DE126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133270" y="1170160"/>
              <a:ext cx="857174" cy="1174099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="" xmlns:a16="http://schemas.microsoft.com/office/drawing/2014/main" id="{396DE98C-0EE9-6C42-81AA-FFFA4548FF8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14897" y="2866318"/>
              <a:ext cx="734218" cy="636141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="" xmlns:a16="http://schemas.microsoft.com/office/drawing/2014/main" id="{5AC6F025-3B4C-0D45-A82E-AB7B64DFE75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270042" y="2310710"/>
              <a:ext cx="877197" cy="124774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="" xmlns:a16="http://schemas.microsoft.com/office/drawing/2014/main" id="{1A5A0B64-37E1-B24A-872B-027DB65C3541}"/>
                </a:ext>
              </a:extLst>
            </p:cNvPr>
            <p:cNvCxnSpPr>
              <a:cxnSpLocks/>
              <a:endCxn id="36" idx="6"/>
            </p:cNvCxnSpPr>
            <p:nvPr/>
          </p:nvCxnSpPr>
          <p:spPr>
            <a:xfrm flipV="1">
              <a:off x="7355323" y="2394186"/>
              <a:ext cx="209067" cy="61459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53" name="Block Arc 52">
              <a:extLst>
                <a:ext uri="{FF2B5EF4-FFF2-40B4-BE49-F238E27FC236}">
                  <a16:creationId xmlns="" xmlns:a16="http://schemas.microsoft.com/office/drawing/2014/main" id="{C4EF102B-11C7-B946-8DD2-106A0AA19CE6}"/>
                </a:ext>
              </a:extLst>
            </p:cNvPr>
            <p:cNvSpPr/>
            <p:nvPr/>
          </p:nvSpPr>
          <p:spPr>
            <a:xfrm>
              <a:off x="5296965" y="1268120"/>
              <a:ext cx="2185416" cy="1911096"/>
            </a:xfrm>
            <a:prstGeom prst="blockArc">
              <a:avLst>
                <a:gd name="adj1" fmla="val 11315919"/>
                <a:gd name="adj2" fmla="val 21317241"/>
                <a:gd name="adj3" fmla="val 0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54" name="Block Arc 53">
              <a:extLst>
                <a:ext uri="{FF2B5EF4-FFF2-40B4-BE49-F238E27FC236}">
                  <a16:creationId xmlns="" xmlns:a16="http://schemas.microsoft.com/office/drawing/2014/main" id="{764F3E99-07D8-7745-B7E9-826B841C25F0}"/>
                </a:ext>
              </a:extLst>
            </p:cNvPr>
            <p:cNvSpPr/>
            <p:nvPr/>
          </p:nvSpPr>
          <p:spPr>
            <a:xfrm rot="13192784">
              <a:off x="5241938" y="1643922"/>
              <a:ext cx="2090373" cy="1828800"/>
            </a:xfrm>
            <a:prstGeom prst="blockArc">
              <a:avLst>
                <a:gd name="adj1" fmla="val 12437006"/>
                <a:gd name="adj2" fmla="val 20328507"/>
                <a:gd name="adj3" fmla="val 0"/>
              </a:avLst>
            </a:prstGeom>
            <a:ln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25775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0254886D-99FE-4349-8B37-ACCFF305F1E4}"/>
              </a:ext>
            </a:extLst>
          </p:cNvPr>
          <p:cNvSpPr txBox="1"/>
          <p:nvPr/>
        </p:nvSpPr>
        <p:spPr>
          <a:xfrm>
            <a:off x="491174" y="263013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</a:t>
            </a:r>
            <a:r>
              <a:rPr lang="en-US" b="1" dirty="0" smtClean="0"/>
              <a:t>S4</a:t>
            </a:r>
            <a:endParaRPr lang="en-US" b="1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BF09CB5E-F10C-274C-92F0-5A6F234FD7F6}"/>
              </a:ext>
            </a:extLst>
          </p:cNvPr>
          <p:cNvCxnSpPr>
            <a:cxnSpLocks/>
          </p:cNvCxnSpPr>
          <p:nvPr/>
        </p:nvCxnSpPr>
        <p:spPr>
          <a:xfrm>
            <a:off x="2592016" y="1056760"/>
            <a:ext cx="2089195" cy="1031746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F5643088-2608-AF48-A9A9-80AA6EA7FEF3}"/>
              </a:ext>
            </a:extLst>
          </p:cNvPr>
          <p:cNvCxnSpPr>
            <a:cxnSpLocks/>
          </p:cNvCxnSpPr>
          <p:nvPr/>
        </p:nvCxnSpPr>
        <p:spPr>
          <a:xfrm flipH="1" flipV="1">
            <a:off x="988369" y="3773810"/>
            <a:ext cx="2249566" cy="118358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F687B00B-01FF-384A-9E21-4495ACD4B7CC}"/>
              </a:ext>
            </a:extLst>
          </p:cNvPr>
          <p:cNvSpPr txBox="1"/>
          <p:nvPr/>
        </p:nvSpPr>
        <p:spPr>
          <a:xfrm>
            <a:off x="3936922" y="3676154"/>
            <a:ext cx="127795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KP52</a:t>
            </a:r>
          </a:p>
          <a:p>
            <a:pPr algn="ctr"/>
            <a:r>
              <a:rPr lang="en-US" sz="1050" b="1" dirty="0"/>
              <a:t>(MG1655 </a:t>
            </a:r>
            <a:r>
              <a:rPr lang="en-US" sz="1050" b="1" i="1" dirty="0"/>
              <a:t>relA1</a:t>
            </a:r>
            <a:r>
              <a:rPr lang="en-US" sz="1050" b="1" dirty="0"/>
              <a:t>)</a:t>
            </a:r>
            <a:endParaRPr lang="en-US" sz="1050" b="1" i="1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B32DCEA9-E165-0146-A3D7-4591B9AAAFC5}"/>
              </a:ext>
            </a:extLst>
          </p:cNvPr>
          <p:cNvSpPr txBox="1"/>
          <p:nvPr/>
        </p:nvSpPr>
        <p:spPr>
          <a:xfrm>
            <a:off x="1122706" y="4365604"/>
            <a:ext cx="1277957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KP56</a:t>
            </a:r>
          </a:p>
          <a:p>
            <a:pPr algn="ctr"/>
            <a:r>
              <a:rPr lang="en-US" sz="1050" b="1" dirty="0"/>
              <a:t>(MG1655 </a:t>
            </a:r>
            <a:r>
              <a:rPr lang="en-US" sz="1050" b="1" i="1" dirty="0"/>
              <a:t>relA1 spoT202</a:t>
            </a:r>
            <a:r>
              <a:rPr lang="en-US" sz="1050" b="1" dirty="0"/>
              <a:t>)</a:t>
            </a:r>
            <a:endParaRPr lang="en-US" sz="1050" b="1" i="1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4EEF3D6C-9121-2D47-8B14-DA70D6AEB02E}"/>
              </a:ext>
            </a:extLst>
          </p:cNvPr>
          <p:cNvSpPr txBox="1"/>
          <p:nvPr/>
        </p:nvSpPr>
        <p:spPr>
          <a:xfrm>
            <a:off x="3373842" y="1056760"/>
            <a:ext cx="127795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KP58</a:t>
            </a:r>
          </a:p>
          <a:p>
            <a:pPr algn="ctr"/>
            <a:r>
              <a:rPr lang="en-US" sz="1050" b="1" dirty="0"/>
              <a:t>(MG1655 </a:t>
            </a:r>
            <a:r>
              <a:rPr lang="en-US" sz="1050" b="1" i="1" dirty="0"/>
              <a:t>spoT202</a:t>
            </a:r>
            <a:r>
              <a:rPr lang="en-US" sz="1050" b="1" dirty="0"/>
              <a:t>)</a:t>
            </a:r>
            <a:endParaRPr lang="en-US" sz="1050" b="1" i="1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1D0F963E-4A00-BE4A-9521-CE7D133CE184}"/>
              </a:ext>
            </a:extLst>
          </p:cNvPr>
          <p:cNvSpPr txBox="1"/>
          <p:nvPr/>
        </p:nvSpPr>
        <p:spPr>
          <a:xfrm>
            <a:off x="559626" y="2207970"/>
            <a:ext cx="127795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MG1655 </a:t>
            </a:r>
            <a:endParaRPr lang="en-US" sz="1050" b="1" i="1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B516F76D-A2C0-2043-BEF3-B4340A2DB1EF}"/>
              </a:ext>
            </a:extLst>
          </p:cNvPr>
          <p:cNvSpPr txBox="1"/>
          <p:nvPr/>
        </p:nvSpPr>
        <p:spPr>
          <a:xfrm>
            <a:off x="2400663" y="218042"/>
            <a:ext cx="428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="" xmlns:a16="http://schemas.microsoft.com/office/drawing/2014/main" id="{4FA35672-AC77-5B49-A769-D1010B327F7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97" t="14445" b="12223"/>
          <a:stretch/>
        </p:blipFill>
        <p:spPr>
          <a:xfrm>
            <a:off x="1258613" y="1340629"/>
            <a:ext cx="3257279" cy="3319272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338ABBC6-3DD4-4D42-B9F0-328C18BA848B}"/>
              </a:ext>
            </a:extLst>
          </p:cNvPr>
          <p:cNvSpPr txBox="1"/>
          <p:nvPr/>
        </p:nvSpPr>
        <p:spPr>
          <a:xfrm>
            <a:off x="6832822" y="416345"/>
            <a:ext cx="4284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pic>
        <p:nvPicPr>
          <p:cNvPr id="13318" name="Picture 6" descr="https://lh3.googleusercontent.com/kYBMid5WyRYm76YD5VJEti5i35N2eK_J8wXyk4wCC6XhAT_rkDlRhUhECxePGL4qrJ_NDivdqrnwkpxhVyQ61rHQrtDlwyKwV9RQpqCjoI-4MXTFOesHMCaW5Ecm2JvCwqGlOwakNmA3UVG_iGN9ggiRvFGLf2fGqD1yUwb0xyEPhE1Xgp2xaDjh_nyjMMN6cM8HxLHJzV7Ktjzp4SYTB8RJOwrD4jZKcwZMgTnRMQ-JcefX5JN88Oz-Dgd9cIIasoGEluuETzY9T9M5wYI45kqcAurC6206muDIdyddkxrfGmbU-IYXkETO3Jl6Lh0gJ7MH26uGmrsuO97pH51Nw2U8l52McDZF7ofU_AfjTL2JSiQ9xLqTubDeTws3JCC8pZGzDdzMrWhI3a-BApbgjRmXcJwXDJkGKQEuV-PN5B8bQg5fUawHulf2WdRYGimLOs0oq3nOQR0uy3-4O3MXUgGYBG2V-FBGoGMVJ23YR1bd8Zg4rcspYxax2THNoe1QoJOIE-9UNvZh4IpdLf8ik_DePGJtov-kPUw9BibRTq70O801Gpk4-2UvIB7_uit2gdakd4ZrznDGQs5z8Uj3BTuNyadvfWijcqaItf1fLr4_oMibg2IDFLO3DkLTZK86wXCIncyUYMwsskod3HC0BIpGeWbLV-XfaL3ccgwH-mVwd7rHp9y_GdomzAHwLiI=w904-h678-no?authuser=0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73" t="5640" r="17167" b="3216"/>
          <a:stretch/>
        </p:blipFill>
        <p:spPr bwMode="auto">
          <a:xfrm>
            <a:off x="7772400" y="1606731"/>
            <a:ext cx="2677219" cy="2873829"/>
          </a:xfrm>
          <a:prstGeom prst="ellipse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6" name="TextBox 45"/>
          <p:cNvSpPr txBox="1"/>
          <p:nvPr/>
        </p:nvSpPr>
        <p:spPr>
          <a:xfrm rot="16200000" flipH="1">
            <a:off x="7722972" y="3000814"/>
            <a:ext cx="3560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8921461" y="163719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51" name="TextBox 50"/>
          <p:cNvSpPr txBox="1"/>
          <p:nvPr/>
        </p:nvSpPr>
        <p:spPr>
          <a:xfrm rot="17544915">
            <a:off x="8053310" y="208616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52" name="TextBox 51"/>
          <p:cNvSpPr txBox="1"/>
          <p:nvPr/>
        </p:nvSpPr>
        <p:spPr>
          <a:xfrm rot="4825457">
            <a:off x="10192817" y="2752622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53" name="TextBox 52"/>
          <p:cNvSpPr txBox="1"/>
          <p:nvPr/>
        </p:nvSpPr>
        <p:spPr>
          <a:xfrm rot="2119038">
            <a:off x="9836206" y="192348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54" name="TextBox 53"/>
          <p:cNvSpPr txBox="1"/>
          <p:nvPr/>
        </p:nvSpPr>
        <p:spPr>
          <a:xfrm rot="7129513">
            <a:off x="9851816" y="382993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55" name="TextBox 54"/>
          <p:cNvSpPr txBox="1"/>
          <p:nvPr/>
        </p:nvSpPr>
        <p:spPr>
          <a:xfrm rot="13432125">
            <a:off x="8120216" y="3884608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8</a:t>
            </a:r>
          </a:p>
        </p:txBody>
      </p:sp>
      <p:sp>
        <p:nvSpPr>
          <p:cNvPr id="56" name="TextBox 55"/>
          <p:cNvSpPr txBox="1"/>
          <p:nvPr/>
        </p:nvSpPr>
        <p:spPr>
          <a:xfrm rot="9012333">
            <a:off x="9170003" y="424280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A34DECB5-D67C-754B-B0A8-6A2483342258}"/>
              </a:ext>
            </a:extLst>
          </p:cNvPr>
          <p:cNvSpPr txBox="1"/>
          <p:nvPr/>
        </p:nvSpPr>
        <p:spPr>
          <a:xfrm>
            <a:off x="8251823" y="1075066"/>
            <a:ext cx="1277957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KP56</a:t>
            </a:r>
          </a:p>
          <a:p>
            <a:pPr algn="ctr"/>
            <a:r>
              <a:rPr lang="en-US" sz="1050" b="1" dirty="0"/>
              <a:t>(MG1655 </a:t>
            </a:r>
            <a:r>
              <a:rPr lang="en-US" sz="1050" b="1" i="1" dirty="0"/>
              <a:t>relA1 spoT202</a:t>
            </a:r>
            <a:r>
              <a:rPr lang="en-US" sz="1050" b="1" dirty="0"/>
              <a:t>)</a:t>
            </a:r>
            <a:endParaRPr lang="en-US" sz="1050" b="1" i="1" dirty="0"/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902D3591-7CD1-AE44-AFDE-2EEDCAC9B216}"/>
              </a:ext>
            </a:extLst>
          </p:cNvPr>
          <p:cNvSpPr txBox="1"/>
          <p:nvPr/>
        </p:nvSpPr>
        <p:spPr>
          <a:xfrm>
            <a:off x="8676827" y="4493290"/>
            <a:ext cx="127795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/>
              <a:t>KP57</a:t>
            </a:r>
          </a:p>
          <a:p>
            <a:pPr algn="ctr"/>
            <a:r>
              <a:rPr lang="en-US" sz="1050" b="1" dirty="0"/>
              <a:t>(MG1655 </a:t>
            </a:r>
            <a:r>
              <a:rPr lang="en-US" sz="1050" b="1" i="1" dirty="0"/>
              <a:t>relA1</a:t>
            </a:r>
            <a:r>
              <a:rPr lang="en-US" sz="1050" b="1" dirty="0"/>
              <a:t>)</a:t>
            </a:r>
            <a:endParaRPr lang="en-US" sz="1050" b="1" i="1" dirty="0"/>
          </a:p>
        </p:txBody>
      </p:sp>
    </p:spTree>
    <p:extLst>
      <p:ext uri="{BB962C8B-B14F-4D97-AF65-F5344CB8AC3E}">
        <p14:creationId xmlns:p14="http://schemas.microsoft.com/office/powerpoint/2010/main" val="21040925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7</Words>
  <Application>Microsoft Office PowerPoint</Application>
  <PresentationFormat>Widescreen</PresentationFormat>
  <Paragraphs>56</Paragraphs>
  <Slides>3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haroni</vt:lpstr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ashree pohnerkar</dc:creator>
  <cp:lastModifiedBy>jayashree pohnerkar</cp:lastModifiedBy>
  <cp:revision>3</cp:revision>
  <dcterms:created xsi:type="dcterms:W3CDTF">2021-03-20T19:24:37Z</dcterms:created>
  <dcterms:modified xsi:type="dcterms:W3CDTF">2021-03-20T19:29:40Z</dcterms:modified>
</cp:coreProperties>
</file>